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1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1FDF8AE1-3BC3-43FD-A37C-6BD4F28C0006}" v="1" dt="2025-03-22T00:19:16.208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2476" autoAdjust="0"/>
    <p:restoredTop sz="96301" autoAdjust="0"/>
  </p:normalViewPr>
  <p:slideViewPr>
    <p:cSldViewPr snapToGrid="0">
      <p:cViewPr varScale="1">
        <p:scale>
          <a:sx n="118" d="100"/>
          <a:sy n="118" d="100"/>
        </p:scale>
        <p:origin x="1008" y="1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合田 朋仁" userId="bbfca4cf-e69f-40e7-8699-565989a18272" providerId="ADAL" clId="{DE2A81C6-6988-4D89-BA15-F735771F00B8}"/>
    <pc:docChg chg="addSld modSld">
      <pc:chgData name="合田 朋仁" userId="bbfca4cf-e69f-40e7-8699-565989a18272" providerId="ADAL" clId="{DE2A81C6-6988-4D89-BA15-F735771F00B8}" dt="2024-12-02T23:18:26.891" v="13" actId="22"/>
      <pc:docMkLst>
        <pc:docMk/>
      </pc:docMkLst>
      <pc:sldChg chg="addSp delSp modSp new mod">
        <pc:chgData name="合田 朋仁" userId="bbfca4cf-e69f-40e7-8699-565989a18272" providerId="ADAL" clId="{DE2A81C6-6988-4D89-BA15-F735771F00B8}" dt="2024-12-02T23:11:39.333" v="3" actId="165"/>
        <pc:sldMkLst>
          <pc:docMk/>
          <pc:sldMk cId="984330866" sldId="257"/>
        </pc:sldMkLst>
      </pc:sldChg>
      <pc:sldChg chg="addSp delSp modSp new mod">
        <pc:chgData name="合田 朋仁" userId="bbfca4cf-e69f-40e7-8699-565989a18272" providerId="ADAL" clId="{DE2A81C6-6988-4D89-BA15-F735771F00B8}" dt="2024-12-02T23:13:11.781" v="7" actId="165"/>
        <pc:sldMkLst>
          <pc:docMk/>
          <pc:sldMk cId="3915891241" sldId="258"/>
        </pc:sldMkLst>
      </pc:sldChg>
      <pc:sldChg chg="addSp new mod">
        <pc:chgData name="合田 朋仁" userId="bbfca4cf-e69f-40e7-8699-565989a18272" providerId="ADAL" clId="{DE2A81C6-6988-4D89-BA15-F735771F00B8}" dt="2024-12-02T23:16:13.263" v="9" actId="22"/>
        <pc:sldMkLst>
          <pc:docMk/>
          <pc:sldMk cId="2565727191" sldId="259"/>
        </pc:sldMkLst>
      </pc:sldChg>
      <pc:sldChg chg="addSp new mod">
        <pc:chgData name="合田 朋仁" userId="bbfca4cf-e69f-40e7-8699-565989a18272" providerId="ADAL" clId="{DE2A81C6-6988-4D89-BA15-F735771F00B8}" dt="2024-12-02T23:17:25.235" v="11" actId="22"/>
        <pc:sldMkLst>
          <pc:docMk/>
          <pc:sldMk cId="61921102" sldId="260"/>
        </pc:sldMkLst>
      </pc:sldChg>
      <pc:sldChg chg="addSp new mod">
        <pc:chgData name="合田 朋仁" userId="bbfca4cf-e69f-40e7-8699-565989a18272" providerId="ADAL" clId="{DE2A81C6-6988-4D89-BA15-F735771F00B8}" dt="2024-12-02T23:18:26.891" v="13" actId="22"/>
        <pc:sldMkLst>
          <pc:docMk/>
          <pc:sldMk cId="3116865027" sldId="261"/>
        </pc:sldMkLst>
      </pc:sldChg>
    </pc:docChg>
  </pc:docChgLst>
  <pc:docChgLst>
    <pc:chgData name="合田 朋仁" userId="bbfca4cf-e69f-40e7-8699-565989a18272" providerId="ADAL" clId="{061E1F08-45B2-4752-9776-FC3783376A46}"/>
    <pc:docChg chg="custSel addSld modSld sldOrd">
      <pc:chgData name="合田 朋仁" userId="bbfca4cf-e69f-40e7-8699-565989a18272" providerId="ADAL" clId="{061E1F08-45B2-4752-9776-FC3783376A46}" dt="2024-12-04T04:43:13.821" v="1255"/>
      <pc:docMkLst>
        <pc:docMk/>
      </pc:docMkLst>
      <pc:sldChg chg="addSp delSp modSp mod ord">
        <pc:chgData name="合田 朋仁" userId="bbfca4cf-e69f-40e7-8699-565989a18272" providerId="ADAL" clId="{061E1F08-45B2-4752-9776-FC3783376A46}" dt="2024-12-04T04:43:11.512" v="1253"/>
        <pc:sldMkLst>
          <pc:docMk/>
          <pc:sldMk cId="4292278888" sldId="256"/>
        </pc:sldMkLst>
      </pc:sldChg>
      <pc:sldChg chg="new">
        <pc:chgData name="合田 朋仁" userId="bbfca4cf-e69f-40e7-8699-565989a18272" providerId="ADAL" clId="{061E1F08-45B2-4752-9776-FC3783376A46}" dt="2024-12-04T03:57:29.019" v="98" actId="680"/>
        <pc:sldMkLst>
          <pc:docMk/>
          <pc:sldMk cId="2166850166" sldId="258"/>
        </pc:sldMkLst>
      </pc:sldChg>
      <pc:sldChg chg="addSp delSp modSp add mod ord">
        <pc:chgData name="合田 朋仁" userId="bbfca4cf-e69f-40e7-8699-565989a18272" providerId="ADAL" clId="{061E1F08-45B2-4752-9776-FC3783376A46}" dt="2024-12-04T04:43:13.821" v="1255"/>
        <pc:sldMkLst>
          <pc:docMk/>
          <pc:sldMk cId="3244835907" sldId="261"/>
        </pc:sldMkLst>
      </pc:sldChg>
    </pc:docChg>
  </pc:docChgLst>
  <pc:docChgLst>
    <pc:chgData name="Tomohito Gohda" userId="16111118910_tp_box_2" providerId="OAuth2" clId="{1FDF8AE1-3BC3-43FD-A37C-6BD4F28C0006}"/>
    <pc:docChg chg="modSld">
      <pc:chgData name="Tomohito Gohda" userId="16111118910_tp_box_2" providerId="OAuth2" clId="{1FDF8AE1-3BC3-43FD-A37C-6BD4F28C0006}" dt="2025-03-22T00:19:32.605" v="13" actId="14100"/>
      <pc:docMkLst>
        <pc:docMk/>
      </pc:docMkLst>
      <pc:sldChg chg="delSp modSp mod">
        <pc:chgData name="Tomohito Gohda" userId="16111118910_tp_box_2" providerId="OAuth2" clId="{1FDF8AE1-3BC3-43FD-A37C-6BD4F28C0006}" dt="2025-03-22T00:19:32.605" v="13" actId="14100"/>
        <pc:sldMkLst>
          <pc:docMk/>
          <pc:sldMk cId="3244835907" sldId="261"/>
        </pc:sldMkLst>
        <pc:spChg chg="mod topLvl">
          <ac:chgData name="Tomohito Gohda" userId="16111118910_tp_box_2" providerId="OAuth2" clId="{1FDF8AE1-3BC3-43FD-A37C-6BD4F28C0006}" dt="2025-03-22T00:19:32.605" v="13" actId="14100"/>
          <ac:spMkLst>
            <pc:docMk/>
            <pc:sldMk cId="3244835907" sldId="261"/>
            <ac:spMk id="2" creationId="{A3F1FA06-F6C3-07FB-50F5-546B3D34F6CA}"/>
          </ac:spMkLst>
        </pc:spChg>
        <pc:spChg chg="mod topLvl">
          <ac:chgData name="Tomohito Gohda" userId="16111118910_tp_box_2" providerId="OAuth2" clId="{1FDF8AE1-3BC3-43FD-A37C-6BD4F28C0006}" dt="2025-03-22T00:19:16.208" v="0" actId="165"/>
          <ac:spMkLst>
            <pc:docMk/>
            <pc:sldMk cId="3244835907" sldId="261"/>
            <ac:spMk id="3" creationId="{2630D3B3-47A9-B8B3-D566-B6C62DE38FA9}"/>
          </ac:spMkLst>
        </pc:spChg>
        <pc:spChg chg="mod topLvl">
          <ac:chgData name="Tomohito Gohda" userId="16111118910_tp_box_2" providerId="OAuth2" clId="{1FDF8AE1-3BC3-43FD-A37C-6BD4F28C0006}" dt="2025-03-22T00:19:16.208" v="0" actId="165"/>
          <ac:spMkLst>
            <pc:docMk/>
            <pc:sldMk cId="3244835907" sldId="261"/>
            <ac:spMk id="4" creationId="{7DB1B83A-15C4-68B1-AFE6-919BE5D65D7E}"/>
          </ac:spMkLst>
        </pc:spChg>
        <pc:spChg chg="mod topLvl">
          <ac:chgData name="Tomohito Gohda" userId="16111118910_tp_box_2" providerId="OAuth2" clId="{1FDF8AE1-3BC3-43FD-A37C-6BD4F28C0006}" dt="2025-03-22T00:19:16.208" v="0" actId="165"/>
          <ac:spMkLst>
            <pc:docMk/>
            <pc:sldMk cId="3244835907" sldId="261"/>
            <ac:spMk id="8" creationId="{E1A20840-9C37-B69D-3BFF-60353B4FEDD1}"/>
          </ac:spMkLst>
        </pc:spChg>
        <pc:spChg chg="mod topLvl">
          <ac:chgData name="Tomohito Gohda" userId="16111118910_tp_box_2" providerId="OAuth2" clId="{1FDF8AE1-3BC3-43FD-A37C-6BD4F28C0006}" dt="2025-03-22T00:19:16.208" v="0" actId="165"/>
          <ac:spMkLst>
            <pc:docMk/>
            <pc:sldMk cId="3244835907" sldId="261"/>
            <ac:spMk id="9" creationId="{FF46FC0D-FD4F-F2EA-EF95-B71B0D48E91D}"/>
          </ac:spMkLst>
        </pc:spChg>
        <pc:grpChg chg="del">
          <ac:chgData name="Tomohito Gohda" userId="16111118910_tp_box_2" providerId="OAuth2" clId="{1FDF8AE1-3BC3-43FD-A37C-6BD4F28C0006}" dt="2025-03-22T00:19:16.208" v="0" actId="165"/>
          <ac:grpSpMkLst>
            <pc:docMk/>
            <pc:sldMk cId="3244835907" sldId="261"/>
            <ac:grpSpMk id="5" creationId="{2887A0F5-8920-5D92-F06F-37C98B939ABC}"/>
          </ac:grpSpMkLst>
        </pc:grpChg>
        <pc:cxnChg chg="mod topLvl">
          <ac:chgData name="Tomohito Gohda" userId="16111118910_tp_box_2" providerId="OAuth2" clId="{1FDF8AE1-3BC3-43FD-A37C-6BD4F28C0006}" dt="2025-03-22T00:19:16.208" v="0" actId="165"/>
          <ac:cxnSpMkLst>
            <pc:docMk/>
            <pc:sldMk cId="3244835907" sldId="261"/>
            <ac:cxnSpMk id="10" creationId="{31BBB259-0B63-A718-61E4-529002A93B54}"/>
          </ac:cxnSpMkLst>
        </pc:cxnChg>
        <pc:cxnChg chg="mod topLvl">
          <ac:chgData name="Tomohito Gohda" userId="16111118910_tp_box_2" providerId="OAuth2" clId="{1FDF8AE1-3BC3-43FD-A37C-6BD4F28C0006}" dt="2025-03-22T00:19:16.208" v="0" actId="165"/>
          <ac:cxnSpMkLst>
            <pc:docMk/>
            <pc:sldMk cId="3244835907" sldId="261"/>
            <ac:cxnSpMk id="12" creationId="{BBD199C5-5C5C-7C75-C9F9-FB0214B44F17}"/>
          </ac:cxnSpMkLst>
        </pc:cxnChg>
        <pc:cxnChg chg="mod topLvl">
          <ac:chgData name="Tomohito Gohda" userId="16111118910_tp_box_2" providerId="OAuth2" clId="{1FDF8AE1-3BC3-43FD-A37C-6BD4F28C0006}" dt="2025-03-22T00:19:16.208" v="0" actId="165"/>
          <ac:cxnSpMkLst>
            <pc:docMk/>
            <pc:sldMk cId="3244835907" sldId="261"/>
            <ac:cxnSpMk id="20" creationId="{6BE4DB39-0757-9676-BB7A-C193680CF43A}"/>
          </ac:cxnSpMkLst>
        </pc:cxnChg>
        <pc:cxnChg chg="mod topLvl">
          <ac:chgData name="Tomohito Gohda" userId="16111118910_tp_box_2" providerId="OAuth2" clId="{1FDF8AE1-3BC3-43FD-A37C-6BD4F28C0006}" dt="2025-03-22T00:19:16.208" v="0" actId="165"/>
          <ac:cxnSpMkLst>
            <pc:docMk/>
            <pc:sldMk cId="3244835907" sldId="261"/>
            <ac:cxnSpMk id="21" creationId="{A8F8427A-9635-3A33-BC8F-C9FDCF778ABD}"/>
          </ac:cxnSpMkLst>
        </pc:cxnChg>
      </pc:sldChg>
    </pc:docChg>
  </pc:docChgLst>
  <pc:docChgLst>
    <pc:chgData name="Tomohito Gohda" userId="16111118910_tp_box_2" providerId="OAuth2" clId="{C6C7E859-F7CD-5345-AE73-35637A321C44}"/>
    <pc:docChg chg="custSel modSld">
      <pc:chgData name="Tomohito Gohda" userId="16111118910_tp_box_2" providerId="OAuth2" clId="{C6C7E859-F7CD-5345-AE73-35637A321C44}" dt="2024-12-20T10:03:13.503" v="573" actId="164"/>
      <pc:docMkLst>
        <pc:docMk/>
      </pc:docMkLst>
      <pc:sldChg chg="addSp delSp modSp mod">
        <pc:chgData name="Tomohito Gohda" userId="16111118910_tp_box_2" providerId="OAuth2" clId="{C6C7E859-F7CD-5345-AE73-35637A321C44}" dt="2024-12-20T10:03:13.503" v="573" actId="164"/>
        <pc:sldMkLst>
          <pc:docMk/>
          <pc:sldMk cId="4292278888" sldId="256"/>
        </pc:sldMkLst>
      </pc:sldChg>
    </pc:docChg>
  </pc:docChgLst>
  <pc:docChgLst>
    <pc:chgData name="Tomohito Gohda" userId="16111118910_tp_box_2" providerId="OAuth2" clId="{1741C875-B116-5549-852B-DE981EC4AA52}"/>
    <pc:docChg chg="delSld">
      <pc:chgData name="Tomohito Gohda" userId="16111118910_tp_box_2" providerId="OAuth2" clId="{1741C875-B116-5549-852B-DE981EC4AA52}" dt="2025-03-22T10:26:19.183" v="0" actId="2696"/>
      <pc:docMkLst>
        <pc:docMk/>
      </pc:docMkLst>
      <pc:sldChg chg="del">
        <pc:chgData name="Tomohito Gohda" userId="16111118910_tp_box_2" providerId="OAuth2" clId="{1741C875-B116-5549-852B-DE981EC4AA52}" dt="2025-03-22T10:26:19.183" v="0" actId="2696"/>
        <pc:sldMkLst>
          <pc:docMk/>
          <pc:sldMk cId="4292278888" sldId="256"/>
        </pc:sldMkLst>
      </pc:sldChg>
    </pc:docChg>
  </pc:docChgLst>
  <pc:docChgLst>
    <pc:chgData name="Tomohito Gohda" userId="16111118910_tp_box_2" providerId="OAuth2" clId="{3AF92FA4-99A4-4961-8211-E6357911F98E}"/>
    <pc:docChg chg="modSld">
      <pc:chgData name="Tomohito Gohda" userId="16111118910_tp_box_2" providerId="OAuth2" clId="{3AF92FA4-99A4-4961-8211-E6357911F98E}" dt="2024-12-05T14:25:54.241" v="547" actId="1036"/>
      <pc:docMkLst>
        <pc:docMk/>
      </pc:docMkLst>
      <pc:sldChg chg="addSp modSp">
        <pc:chgData name="Tomohito Gohda" userId="16111118910_tp_box_2" providerId="OAuth2" clId="{3AF92FA4-99A4-4961-8211-E6357911F98E}" dt="2024-12-05T14:24:35.416" v="397" actId="1036"/>
        <pc:sldMkLst>
          <pc:docMk/>
          <pc:sldMk cId="4292278888" sldId="256"/>
        </pc:sldMkLst>
      </pc:sldChg>
      <pc:sldChg chg="addSp modSp mod">
        <pc:chgData name="Tomohito Gohda" userId="16111118910_tp_box_2" providerId="OAuth2" clId="{3AF92FA4-99A4-4961-8211-E6357911F98E}" dt="2024-12-05T14:24:53.247" v="417" actId="1035"/>
        <pc:sldMkLst>
          <pc:docMk/>
          <pc:sldMk cId="3244835907" sldId="261"/>
        </pc:sldMkLst>
      </pc:sldChg>
      <pc:sldChg chg="addSp modSp mod">
        <pc:chgData name="Tomohito Gohda" userId="16111118910_tp_box_2" providerId="OAuth2" clId="{3AF92FA4-99A4-4961-8211-E6357911F98E}" dt="2024-12-05T14:25:54.241" v="547" actId="1036"/>
        <pc:sldMkLst>
          <pc:docMk/>
          <pc:sldMk cId="1479788580" sldId="262"/>
        </pc:sldMkLst>
      </pc:sldChg>
    </pc:docChg>
  </pc:docChgLst>
  <pc:docChgLst>
    <pc:chgData name="Tomohito Gohda" userId="16111118910_tp_box_2" providerId="OAuth2" clId="{968A7206-BA77-594F-B3F3-9AB3A0216557}"/>
    <pc:docChg chg="delSld">
      <pc:chgData name="Tomohito Gohda" userId="16111118910_tp_box_2" providerId="OAuth2" clId="{968A7206-BA77-594F-B3F3-9AB3A0216557}" dt="2024-12-26T12:20:16.583" v="0" actId="2696"/>
      <pc:docMkLst>
        <pc:docMk/>
      </pc:docMkLst>
      <pc:sldChg chg="del">
        <pc:chgData name="Tomohito Gohda" userId="16111118910_tp_box_2" providerId="OAuth2" clId="{968A7206-BA77-594F-B3F3-9AB3A0216557}" dt="2024-12-26T12:20:16.583" v="0" actId="2696"/>
        <pc:sldMkLst>
          <pc:docMk/>
          <pc:sldMk cId="1479788580" sldId="262"/>
        </pc:sldMkLst>
      </pc:sldChg>
    </pc:docChg>
  </pc:docChgLst>
  <pc:docChgLst>
    <pc:chgData name="Tomohito Gohda" userId="16111118910_tp_box_2" providerId="OAuth2" clId="{5F601E06-58C5-1543-9FBB-2B0CB2F0E1B6}"/>
    <pc:docChg chg="modSld">
      <pc:chgData name="Tomohito Gohda" userId="16111118910_tp_box_2" providerId="OAuth2" clId="{5F601E06-58C5-1543-9FBB-2B0CB2F0E1B6}" dt="2024-12-26T13:59:29.181" v="163" actId="12789"/>
      <pc:docMkLst>
        <pc:docMk/>
      </pc:docMkLst>
      <pc:sldChg chg="delSp modSp mod">
        <pc:chgData name="Tomohito Gohda" userId="16111118910_tp_box_2" providerId="OAuth2" clId="{5F601E06-58C5-1543-9FBB-2B0CB2F0E1B6}" dt="2024-12-26T13:59:29.181" v="163" actId="12789"/>
        <pc:sldMkLst>
          <pc:docMk/>
          <pc:sldMk cId="4292278888" sldId="256"/>
        </pc:sldMkLst>
      </pc:sldChg>
    </pc:docChg>
  </pc:docChgLst>
  <pc:docChgLst>
    <pc:chgData name="Tomohito Gohda" userId="16111118910_tp_box_2" providerId="OAuth2" clId="{1429D0E2-FD51-4116-8281-FC9ECD940F09}"/>
    <pc:docChg chg="modSld">
      <pc:chgData name="Tomohito Gohda" userId="16111118910_tp_box_2" providerId="OAuth2" clId="{1429D0E2-FD51-4116-8281-FC9ECD940F09}" dt="2024-12-19T11:38:20.784" v="329" actId="164"/>
      <pc:docMkLst>
        <pc:docMk/>
      </pc:docMkLst>
      <pc:sldChg chg="addSp delSp modSp">
        <pc:chgData name="Tomohito Gohda" userId="16111118910_tp_box_2" providerId="OAuth2" clId="{1429D0E2-FD51-4116-8281-FC9ECD940F09}" dt="2024-12-19T11:38:20.784" v="329" actId="164"/>
        <pc:sldMkLst>
          <pc:docMk/>
          <pc:sldMk cId="1479788580" sldId="262"/>
        </pc:sldMkLst>
      </pc:sldChg>
    </pc:docChg>
  </pc:docChgLst>
  <pc:docChgLst>
    <pc:chgData name="Tomohito Gohda" userId="16111118910_tp_box_2" providerId="OAuth2" clId="{07A23070-D8A9-4692-9575-12589A883F53}"/>
    <pc:docChg chg="modSld">
      <pc:chgData name="Tomohito Gohda" userId="16111118910_tp_box_2" providerId="OAuth2" clId="{07A23070-D8A9-4692-9575-12589A883F53}" dt="2025-03-21T06:09:35.520" v="2" actId="20577"/>
      <pc:docMkLst>
        <pc:docMk/>
      </pc:docMkLst>
      <pc:sldChg chg="modSp mod">
        <pc:chgData name="Tomohito Gohda" userId="16111118910_tp_box_2" providerId="OAuth2" clId="{07A23070-D8A9-4692-9575-12589A883F53}" dt="2025-03-21T06:09:35.520" v="2" actId="20577"/>
        <pc:sldMkLst>
          <pc:docMk/>
          <pc:sldMk cId="4292278888" sldId="256"/>
        </pc:sldMkLst>
        <pc:spChg chg="mod">
          <ac:chgData name="Tomohito Gohda" userId="16111118910_tp_box_2" providerId="OAuth2" clId="{07A23070-D8A9-4692-9575-12589A883F53}" dt="2025-03-21T06:09:35.520" v="2" actId="20577"/>
          <ac:spMkLst>
            <pc:docMk/>
            <pc:sldMk cId="4292278888" sldId="256"/>
            <ac:spMk id="110" creationId="{8332A87B-D880-45B0-BAB7-03D6866DD760}"/>
          </ac:spMkLst>
        </pc:spChg>
      </pc:sldChg>
    </pc:docChg>
  </pc:docChgLst>
  <pc:docChgLst>
    <pc:chgData name="Tomohito Gohda" userId="16111118910_tp_box_2" providerId="OAuth2" clId="{9F839F0C-F81B-424C-8D99-10815188EBF6}"/>
    <pc:docChg chg="modSld">
      <pc:chgData name="Tomohito Gohda" userId="16111118910_tp_box_2" providerId="OAuth2" clId="{9F839F0C-F81B-424C-8D99-10815188EBF6}" dt="2024-12-15T11:35:05.853" v="46" actId="552"/>
      <pc:docMkLst>
        <pc:docMk/>
      </pc:docMkLst>
      <pc:sldChg chg="addSp modSp mod">
        <pc:chgData name="Tomohito Gohda" userId="16111118910_tp_box_2" providerId="OAuth2" clId="{9F839F0C-F81B-424C-8D99-10815188EBF6}" dt="2024-12-15T11:35:05.853" v="46" actId="552"/>
        <pc:sldMkLst>
          <pc:docMk/>
          <pc:sldMk cId="1479788580" sldId="262"/>
        </pc:sldMkLst>
      </pc:sldChg>
    </pc:docChg>
  </pc:docChgLst>
  <pc:docChgLst>
    <pc:chgData name="Tomohito Gohda" userId="16111118910_tp_box_2" providerId="OAuth2" clId="{2EBCA825-7978-4D4B-B6B8-2CF9CD314672}"/>
    <pc:docChg chg="modSld">
      <pc:chgData name="Tomohito Gohda" userId="16111118910_tp_box_2" providerId="OAuth2" clId="{2EBCA825-7978-4D4B-B6B8-2CF9CD314672}" dt="2024-12-20T10:25:22.635" v="1" actId="20577"/>
      <pc:docMkLst>
        <pc:docMk/>
      </pc:docMkLst>
      <pc:sldChg chg="modSp mod">
        <pc:chgData name="Tomohito Gohda" userId="16111118910_tp_box_2" providerId="OAuth2" clId="{2EBCA825-7978-4D4B-B6B8-2CF9CD314672}" dt="2024-12-20T10:25:22.635" v="1" actId="20577"/>
        <pc:sldMkLst>
          <pc:docMk/>
          <pc:sldMk cId="3244835907" sldId="261"/>
        </pc:sldMkLst>
      </pc:sldChg>
    </pc:docChg>
  </pc:docChgLst>
  <pc:docChgLst>
    <pc:chgData name="Tomohito Gohda" userId="16111118910_tp_box_2" providerId="OAuth2" clId="{A1C3C492-121A-4694-A222-D34C681F50DD}"/>
    <pc:docChg chg="modSld">
      <pc:chgData name="Tomohito Gohda" userId="16111118910_tp_box_2" providerId="OAuth2" clId="{A1C3C492-121A-4694-A222-D34C681F50DD}" dt="2024-12-04T12:36:37.223" v="14" actId="732"/>
      <pc:docMkLst>
        <pc:docMk/>
      </pc:docMkLst>
      <pc:sldChg chg="modSp mod">
        <pc:chgData name="Tomohito Gohda" userId="16111118910_tp_box_2" providerId="OAuth2" clId="{A1C3C492-121A-4694-A222-D34C681F50DD}" dt="2024-12-04T12:36:37.223" v="14" actId="732"/>
        <pc:sldMkLst>
          <pc:docMk/>
          <pc:sldMk cId="144359" sldId="262"/>
        </pc:sldMkLst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C81007F-D526-3A3D-4CA0-BDC5D8B7B7B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7184C1A8-BC36-21AC-F34C-5FF97B23A6B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6CC2A516-193C-888C-C0EA-23F9822295E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A436D0-09DF-4956-98E8-C4E38CD882D1}" type="datetimeFigureOut">
              <a:rPr kumimoji="1" lang="ja-JP" altLang="en-US" smtClean="0"/>
              <a:t>2025/3/2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1111F33E-2372-8B80-6DB2-5BCBDF15892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B26F86FC-2192-7AF8-F52B-645A044CC4C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A5CC01-4C1D-43D1-99AB-FF55DD37F22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978485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9E4FBBB-B5A9-ECFB-4602-74A6FC7F43C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9127D696-DA1E-9C97-8465-A7B7A3DB951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2A85583C-844B-CBB4-CE87-B5951E57FE5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A436D0-09DF-4956-98E8-C4E38CD882D1}" type="datetimeFigureOut">
              <a:rPr kumimoji="1" lang="ja-JP" altLang="en-US" smtClean="0"/>
              <a:t>2025/3/2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66CA06E4-03E3-6EA2-111A-3019DA8F383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339C4382-24C2-2A75-DF21-F38E2259D7B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A5CC01-4C1D-43D1-99AB-FF55DD37F22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6252920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949B3AE6-43EC-4E6E-F7E8-83369BDA5D0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F2B828F9-455A-DC44-407E-E1B2224BEF5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57B99E29-7AAE-5463-1AA6-7560C174B37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A436D0-09DF-4956-98E8-C4E38CD882D1}" type="datetimeFigureOut">
              <a:rPr kumimoji="1" lang="ja-JP" altLang="en-US" smtClean="0"/>
              <a:t>2025/3/2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618F175C-1DEC-CA2D-03A3-6E8B68E851B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A87C8286-65AE-3AB6-B039-CE20BD23188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A5CC01-4C1D-43D1-99AB-FF55DD37F22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1376788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C663C7E-E8D2-3219-CB21-2C0CD0FCC4B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E57A975A-5A3B-B563-4655-1386D352080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B4992526-775D-5791-B17E-DE5B13317C6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A436D0-09DF-4956-98E8-C4E38CD882D1}" type="datetimeFigureOut">
              <a:rPr kumimoji="1" lang="ja-JP" altLang="en-US" smtClean="0"/>
              <a:t>2025/3/2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0544882A-0948-56ED-53C7-61945C7BC8B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949617FC-BAC1-EE5C-8D93-D37742257DF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A5CC01-4C1D-43D1-99AB-FF55DD37F22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0820486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2CBB970F-F8AC-FB4F-B40C-245D2692B06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5526B035-AFAE-A0FD-0618-86105930DE7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6283B94A-E7B8-3D84-FE9E-4E1ACC6F7EB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A436D0-09DF-4956-98E8-C4E38CD882D1}" type="datetimeFigureOut">
              <a:rPr kumimoji="1" lang="ja-JP" altLang="en-US" smtClean="0"/>
              <a:t>2025/3/2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50E7E308-AAC0-C23C-8920-E221D0D44DA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84A3903B-9859-1413-96DF-84C42BB427F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A5CC01-4C1D-43D1-99AB-FF55DD37F22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4530769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C198333F-975F-BEA7-9B79-2F4BD338460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33083E87-B34C-D6E7-1BC7-AFCEE474516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30EF6E95-84E7-B5AF-A4DC-026BFAF5A10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F38ACC78-FFEE-8192-9B55-BC3F56CEDE7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A436D0-09DF-4956-98E8-C4E38CD882D1}" type="datetimeFigureOut">
              <a:rPr kumimoji="1" lang="ja-JP" altLang="en-US" smtClean="0"/>
              <a:t>2025/3/22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F93965F2-D1DF-EEB6-0CA7-8F851C079A8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2066F8E1-0B2B-2045-4BE8-A873B6E9105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A5CC01-4C1D-43D1-99AB-FF55DD37F22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8639625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959F550-C867-32D7-5442-BF8187E6BB7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ECA600A9-1F09-9B1C-4B4C-700FD7C3689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141E722B-1892-B9A9-3C08-1DDBA6FBFFB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8407F1EB-2EFE-0F18-ADA9-6A03E6E711C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EAD58FFA-7236-A4CF-9113-48313CEF808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F3E91E23-E61D-BAB8-7B5D-8E0C7D38713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A436D0-09DF-4956-98E8-C4E38CD882D1}" type="datetimeFigureOut">
              <a:rPr kumimoji="1" lang="ja-JP" altLang="en-US" smtClean="0"/>
              <a:t>2025/3/22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5C5589DC-8179-8DD7-6876-E3E2117AE19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006DC17B-88B6-642C-C7AC-FC9C83C834B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A5CC01-4C1D-43D1-99AB-FF55DD37F22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3511125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72465CB-F974-34A4-D114-8F0C19C87A9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ECD337D6-FAB9-5D73-EF4A-D7CF173EA6A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A436D0-09DF-4956-98E8-C4E38CD882D1}" type="datetimeFigureOut">
              <a:rPr kumimoji="1" lang="ja-JP" altLang="en-US" smtClean="0"/>
              <a:t>2025/3/22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310D37DF-9B78-0D10-85DF-5611CE946B7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31F358B9-B594-9EE6-D2AC-8A60D3028C6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A5CC01-4C1D-43D1-99AB-FF55DD37F22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4849568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03D8D784-435A-7A9C-BFBE-12C8F679219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A436D0-09DF-4956-98E8-C4E38CD882D1}" type="datetimeFigureOut">
              <a:rPr kumimoji="1" lang="ja-JP" altLang="en-US" smtClean="0"/>
              <a:t>2025/3/22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1E1ABDDA-1E8F-1D06-E429-1ACE4E7F229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B316BFF5-170D-3741-61CC-74B86F09B26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A5CC01-4C1D-43D1-99AB-FF55DD37F22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4399596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211CF087-976D-2B68-DB4B-F1272F665E3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807E5A4F-8279-2502-4E49-95DEA0B5004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442D77A3-C41D-B9A6-6BE0-DD3E4E2CDE6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AB6A162C-576A-4B2D-828C-B95F53C2956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A436D0-09DF-4956-98E8-C4E38CD882D1}" type="datetimeFigureOut">
              <a:rPr kumimoji="1" lang="ja-JP" altLang="en-US" smtClean="0"/>
              <a:t>2025/3/22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BBC9F298-0D37-C57E-D461-72136570017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08DCAD12-F44A-8ADA-DEE2-32A905FF30E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A5CC01-4C1D-43D1-99AB-FF55DD37F22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1880262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A1800F5-2347-EAC2-36FC-4D6FA328D09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A18597B1-5EF4-8D4F-841A-6207CC243BC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DCF31990-2E63-6EE6-AEC4-CDF0E1CF3D8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8A45027F-3CB6-48D5-F71F-25897C93ACE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A436D0-09DF-4956-98E8-C4E38CD882D1}" type="datetimeFigureOut">
              <a:rPr kumimoji="1" lang="ja-JP" altLang="en-US" smtClean="0"/>
              <a:t>2025/3/22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F603394C-D8F8-F761-4195-A132023D731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67F14FED-B12B-6F62-C8A1-E5659C548D3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A5CC01-4C1D-43D1-99AB-FF55DD37F22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9544787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BFF62FE8-C908-45E2-7342-8871646E1F0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891D6E15-CD5E-F29F-895D-11A575D4F69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8ADEBA24-83A0-0D4C-DF6D-3B7855AB4AF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6FA436D0-09DF-4956-98E8-C4E38CD882D1}" type="datetimeFigureOut">
              <a:rPr kumimoji="1" lang="ja-JP" altLang="en-US" smtClean="0"/>
              <a:t>2025/3/2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7ABE8723-AEF3-4A61-76D0-37EA7420E04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DFF5E00C-24A8-334F-7994-1D852D9DB83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B8A5CC01-4C1D-43D1-99AB-FF55DD37F22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3997544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Rectangle 34">
            <a:extLst>
              <a:ext uri="{FF2B5EF4-FFF2-40B4-BE49-F238E27FC236}">
                <a16:creationId xmlns:a16="http://schemas.microsoft.com/office/drawing/2014/main" id="{639BA941-7E04-7017-BC73-3DE13775536C}"/>
              </a:ext>
            </a:extLst>
          </p:cNvPr>
          <p:cNvSpPr>
            <a:spLocks noChangeArrowheads="1"/>
          </p:cNvSpPr>
          <p:nvPr/>
        </p:nvSpPr>
        <p:spPr bwMode="auto">
          <a:xfrm>
            <a:off x="10086520" y="-1701"/>
            <a:ext cx="2082461" cy="346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ctr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/>
            <a:r>
              <a:rPr lang="en-US" altLang="ja-JP" sz="1400" dirty="0">
                <a:solidFill>
                  <a:srgbClr val="000000"/>
                </a:solidFill>
                <a:latin typeface="Segoe UI" panose="020B0502040204020203" pitchFamily="34" charset="0"/>
                <a:cs typeface="Segoe UI" panose="020B0502040204020203" pitchFamily="34" charset="0"/>
              </a:rPr>
              <a:t>Supplementary Figure 1</a:t>
            </a:r>
            <a:endParaRPr kumimoji="0" lang="ja-JP" altLang="ja-JP" sz="1400" dirty="0">
              <a:latin typeface="Segoe UI" panose="020B0502040204020203" pitchFamily="34" charset="0"/>
              <a:cs typeface="Segoe UI" panose="020B0502040204020203" pitchFamily="34" charset="0"/>
            </a:endParaRP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A3F1FA06-F6C3-07FB-50F5-546B3D34F6CA}"/>
              </a:ext>
            </a:extLst>
          </p:cNvPr>
          <p:cNvSpPr txBox="1"/>
          <p:nvPr/>
        </p:nvSpPr>
        <p:spPr>
          <a:xfrm>
            <a:off x="571778" y="621639"/>
            <a:ext cx="2844521" cy="461665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txBody>
          <a:bodyPr wrap="square" rtlCol="0" anchor="ctr">
            <a:spAutoFit/>
          </a:bodyPr>
          <a:lstStyle/>
          <a:p>
            <a:r>
              <a:rPr lang="en-US" altLang="ja-JP" sz="1200" dirty="0">
                <a:latin typeface="Segoe UI" panose="020B0502040204020203" pitchFamily="34" charset="0"/>
                <a:cs typeface="Segoe UI" panose="020B0502040204020203" pitchFamily="34" charset="0"/>
              </a:rPr>
              <a:t>People with diabetes mellitus (n = 738)</a:t>
            </a:r>
          </a:p>
          <a:p>
            <a:r>
              <a:rPr lang="en-US" altLang="ja-JP" sz="1200" dirty="0">
                <a:latin typeface="Segoe UI" panose="020B0502040204020203" pitchFamily="34" charset="0"/>
                <a:cs typeface="Segoe UI" panose="020B0502040204020203" pitchFamily="34" charset="0"/>
              </a:rPr>
              <a:t>July 1, 2014~March 31, 2016)</a:t>
            </a:r>
            <a:endParaRPr lang="ja-JP" altLang="en-US" sz="1200" dirty="0">
              <a:latin typeface="Segoe UI" panose="020B0502040204020203" pitchFamily="34" charset="0"/>
              <a:cs typeface="Segoe UI" panose="020B0502040204020203" pitchFamily="34" charset="0"/>
            </a:endParaRPr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2630D3B3-47A9-B8B3-D566-B6C62DE38FA9}"/>
              </a:ext>
            </a:extLst>
          </p:cNvPr>
          <p:cNvSpPr txBox="1"/>
          <p:nvPr/>
        </p:nvSpPr>
        <p:spPr>
          <a:xfrm>
            <a:off x="2451527" y="1360809"/>
            <a:ext cx="4873541" cy="646331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txBody>
          <a:bodyPr wrap="square" rtlCol="0" anchor="ctr">
            <a:spAutoFit/>
          </a:bodyPr>
          <a:lstStyle/>
          <a:p>
            <a:r>
              <a:rPr lang="en-US" altLang="ja-JP" sz="1200" dirty="0">
                <a:latin typeface="Segoe UI" panose="020B0502040204020203" pitchFamily="34" charset="0"/>
                <a:cs typeface="Segoe UI" panose="020B0502040204020203" pitchFamily="34" charset="0"/>
              </a:rPr>
              <a:t>Undergoing renal replacement therapy (n = 2)</a:t>
            </a:r>
          </a:p>
          <a:p>
            <a:r>
              <a:rPr lang="en-US" altLang="ja-JP" sz="1200" dirty="0">
                <a:latin typeface="Segoe UI" panose="020B0502040204020203" pitchFamily="34" charset="0"/>
                <a:cs typeface="Segoe UI" panose="020B0502040204020203" pitchFamily="34" charset="0"/>
              </a:rPr>
              <a:t>Other types of diabetes except type 1 and type 2 diabetes (n = 19)</a:t>
            </a:r>
          </a:p>
          <a:p>
            <a:r>
              <a:rPr lang="en-US" altLang="ja-JP" sz="1200" dirty="0">
                <a:latin typeface="Segoe UI" panose="020B0502040204020203" pitchFamily="34" charset="0"/>
                <a:cs typeface="Segoe UI" panose="020B0502040204020203" pitchFamily="34" charset="0"/>
              </a:rPr>
              <a:t>Baseline eGFR &lt;30 </a:t>
            </a:r>
            <a:r>
              <a:rPr lang="en-US" altLang="ja-JP" sz="1200" dirty="0">
                <a:latin typeface="Segoe UI" panose="020B0502040204020203" pitchFamily="34" charset="0"/>
                <a:ea typeface="游明朝" panose="02020400000000000000" pitchFamily="18" charset="-128"/>
                <a:cs typeface="Segoe UI" panose="020B0502040204020203" pitchFamily="34" charset="0"/>
              </a:rPr>
              <a:t>mL/min/1.73</a:t>
            </a:r>
            <a:r>
              <a:rPr lang="ja-JP" altLang="en-US" sz="1200" dirty="0">
                <a:latin typeface="Segoe UI" panose="020B0502040204020203" pitchFamily="34" charset="0"/>
                <a:ea typeface="游明朝" panose="02020400000000000000" pitchFamily="18" charset="-128"/>
                <a:cs typeface="Segoe UI" panose="020B0502040204020203" pitchFamily="34" charset="0"/>
              </a:rPr>
              <a:t> </a:t>
            </a:r>
            <a:r>
              <a:rPr lang="en-US" altLang="ja-JP" sz="1200" dirty="0">
                <a:latin typeface="Segoe UI" panose="020B0502040204020203" pitchFamily="34" charset="0"/>
                <a:ea typeface="游明朝" panose="02020400000000000000" pitchFamily="18" charset="-128"/>
                <a:cs typeface="Segoe UI" panose="020B0502040204020203" pitchFamily="34" charset="0"/>
              </a:rPr>
              <a:t>m</a:t>
            </a:r>
            <a:r>
              <a:rPr lang="en-US" altLang="ja-JP" sz="1200" baseline="30000" dirty="0">
                <a:latin typeface="Segoe UI" panose="020B0502040204020203" pitchFamily="34" charset="0"/>
                <a:ea typeface="游明朝" panose="02020400000000000000" pitchFamily="18" charset="-128"/>
                <a:cs typeface="Segoe UI" panose="020B0502040204020203" pitchFamily="34" charset="0"/>
              </a:rPr>
              <a:t>2 </a:t>
            </a:r>
            <a:r>
              <a:rPr lang="en-US" altLang="ja-JP" sz="1200" dirty="0">
                <a:latin typeface="Segoe UI" panose="020B0502040204020203" pitchFamily="34" charset="0"/>
                <a:ea typeface="游明朝" panose="02020400000000000000" pitchFamily="18" charset="-128"/>
                <a:cs typeface="Segoe UI" panose="020B0502040204020203" pitchFamily="34" charset="0"/>
              </a:rPr>
              <a:t>(n = 36)</a:t>
            </a:r>
            <a:endParaRPr lang="ja-JP" altLang="en-US" sz="1200" dirty="0">
              <a:latin typeface="Segoe UI" panose="020B0502040204020203" pitchFamily="34" charset="0"/>
              <a:cs typeface="Segoe UI" panose="020B0502040204020203" pitchFamily="34" charset="0"/>
            </a:endParaRPr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7DB1B83A-15C4-68B1-AFE6-919BE5D65D7E}"/>
              </a:ext>
            </a:extLst>
          </p:cNvPr>
          <p:cNvSpPr txBox="1"/>
          <p:nvPr/>
        </p:nvSpPr>
        <p:spPr>
          <a:xfrm>
            <a:off x="2451527" y="2800464"/>
            <a:ext cx="2349874" cy="646331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txBody>
          <a:bodyPr wrap="none" rtlCol="0" anchor="ctr">
            <a:spAutoFit/>
          </a:bodyPr>
          <a:lstStyle/>
          <a:p>
            <a:r>
              <a:rPr lang="en-US" altLang="ja-JP" sz="1200" dirty="0">
                <a:latin typeface="Segoe UI" panose="020B0502040204020203" pitchFamily="34" charset="0"/>
                <a:cs typeface="Segoe UI" panose="020B0502040204020203" pitchFamily="34" charset="0"/>
              </a:rPr>
              <a:t>Withdrew consent (n = 1)</a:t>
            </a:r>
          </a:p>
          <a:p>
            <a:r>
              <a:rPr lang="en-US" altLang="ja-JP" sz="1200" dirty="0">
                <a:latin typeface="Segoe UI" panose="020B0502040204020203" pitchFamily="34" charset="0"/>
                <a:cs typeface="Segoe UI" panose="020B0502040204020203" pitchFamily="34" charset="0"/>
              </a:rPr>
              <a:t>Follow-up &lt;6 months (n = 40)</a:t>
            </a:r>
            <a:endParaRPr lang="ja-JP" altLang="en-US" sz="1200" dirty="0">
              <a:latin typeface="Segoe UI" panose="020B0502040204020203" pitchFamily="34" charset="0"/>
              <a:cs typeface="Segoe UI" panose="020B0502040204020203" pitchFamily="34" charset="0"/>
            </a:endParaRPr>
          </a:p>
          <a:p>
            <a:r>
              <a:rPr lang="en-US" altLang="ja-JP" sz="1200" dirty="0">
                <a:latin typeface="Segoe UI" panose="020B0502040204020203" pitchFamily="34" charset="0"/>
                <a:cs typeface="Segoe UI" panose="020B0502040204020203" pitchFamily="34" charset="0"/>
              </a:rPr>
              <a:t>No GDF15 measurement (n = 2)</a:t>
            </a:r>
            <a:endParaRPr lang="ja-JP" altLang="en-US" sz="1200" dirty="0">
              <a:latin typeface="Segoe UI" panose="020B0502040204020203" pitchFamily="34" charset="0"/>
              <a:cs typeface="Segoe UI" panose="020B0502040204020203" pitchFamily="34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E1A20840-9C37-B69D-3BFF-60353B4FEDD1}"/>
              </a:ext>
            </a:extLst>
          </p:cNvPr>
          <p:cNvSpPr txBox="1"/>
          <p:nvPr/>
        </p:nvSpPr>
        <p:spPr>
          <a:xfrm>
            <a:off x="571779" y="3702521"/>
            <a:ext cx="2060372" cy="276999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txBody>
          <a:bodyPr wrap="none" rtlCol="0" anchor="ctr">
            <a:spAutoFit/>
          </a:bodyPr>
          <a:lstStyle/>
          <a:p>
            <a:r>
              <a:rPr lang="en-US" altLang="ja-JP" sz="1200" dirty="0">
                <a:latin typeface="Segoe UI" panose="020B0502040204020203" pitchFamily="34" charset="0"/>
                <a:cs typeface="Segoe UI" panose="020B0502040204020203" pitchFamily="34" charset="0"/>
              </a:rPr>
              <a:t>Study participants (n = 638)</a:t>
            </a:r>
            <a:endParaRPr lang="ja-JP" altLang="en-US" sz="1200" dirty="0">
              <a:latin typeface="Segoe UI" panose="020B0502040204020203" pitchFamily="34" charset="0"/>
              <a:cs typeface="Segoe UI" panose="020B0502040204020203" pitchFamily="34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FF46FC0D-FD4F-F2EA-EF95-B71B0D48E91D}"/>
              </a:ext>
            </a:extLst>
          </p:cNvPr>
          <p:cNvSpPr txBox="1"/>
          <p:nvPr/>
        </p:nvSpPr>
        <p:spPr>
          <a:xfrm>
            <a:off x="571779" y="2259124"/>
            <a:ext cx="3358099" cy="276999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txBody>
          <a:bodyPr wrap="none" rtlCol="0" anchor="ctr">
            <a:spAutoFit/>
          </a:bodyPr>
          <a:lstStyle/>
          <a:p>
            <a:r>
              <a:rPr lang="en-US" altLang="ja-JP" sz="1200" dirty="0">
                <a:latin typeface="Segoe UI" panose="020B0502040204020203" pitchFamily="34" charset="0"/>
                <a:cs typeface="Segoe UI" panose="020B0502040204020203" pitchFamily="34" charset="0"/>
              </a:rPr>
              <a:t>People with type 1 or type 2 diabetes (n = 681)</a:t>
            </a:r>
            <a:endParaRPr lang="ja-JP" altLang="en-US" sz="1200" dirty="0">
              <a:latin typeface="Segoe UI" panose="020B0502040204020203" pitchFamily="34" charset="0"/>
              <a:cs typeface="Segoe UI" panose="020B0502040204020203" pitchFamily="34" charset="0"/>
            </a:endParaRPr>
          </a:p>
        </p:txBody>
      </p:sp>
      <p:cxnSp>
        <p:nvCxnSpPr>
          <p:cNvPr id="10" name="直線矢印コネクタ 9">
            <a:extLst>
              <a:ext uri="{FF2B5EF4-FFF2-40B4-BE49-F238E27FC236}">
                <a16:creationId xmlns:a16="http://schemas.microsoft.com/office/drawing/2014/main" id="{31BBB259-0B63-A718-61E4-529002A93B54}"/>
              </a:ext>
            </a:extLst>
          </p:cNvPr>
          <p:cNvCxnSpPr>
            <a:cxnSpLocks/>
          </p:cNvCxnSpPr>
          <p:nvPr/>
        </p:nvCxnSpPr>
        <p:spPr>
          <a:xfrm>
            <a:off x="948771" y="1094881"/>
            <a:ext cx="0" cy="1153852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直線矢印コネクタ 11">
            <a:extLst>
              <a:ext uri="{FF2B5EF4-FFF2-40B4-BE49-F238E27FC236}">
                <a16:creationId xmlns:a16="http://schemas.microsoft.com/office/drawing/2014/main" id="{BBD199C5-5C5C-7C75-C9F9-FB0214B44F17}"/>
              </a:ext>
            </a:extLst>
          </p:cNvPr>
          <p:cNvCxnSpPr>
            <a:cxnSpLocks/>
          </p:cNvCxnSpPr>
          <p:nvPr/>
        </p:nvCxnSpPr>
        <p:spPr>
          <a:xfrm>
            <a:off x="957248" y="1671605"/>
            <a:ext cx="1488482" cy="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直線矢印コネクタ 19">
            <a:extLst>
              <a:ext uri="{FF2B5EF4-FFF2-40B4-BE49-F238E27FC236}">
                <a16:creationId xmlns:a16="http://schemas.microsoft.com/office/drawing/2014/main" id="{6BE4DB39-0757-9676-BB7A-C193680CF43A}"/>
              </a:ext>
            </a:extLst>
          </p:cNvPr>
          <p:cNvCxnSpPr>
            <a:cxnSpLocks/>
          </p:cNvCxnSpPr>
          <p:nvPr/>
        </p:nvCxnSpPr>
        <p:spPr>
          <a:xfrm>
            <a:off x="945306" y="2546146"/>
            <a:ext cx="0" cy="1153852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直線矢印コネクタ 20">
            <a:extLst>
              <a:ext uri="{FF2B5EF4-FFF2-40B4-BE49-F238E27FC236}">
                <a16:creationId xmlns:a16="http://schemas.microsoft.com/office/drawing/2014/main" id="{A8F8427A-9635-3A33-BC8F-C9FDCF778ABD}"/>
              </a:ext>
            </a:extLst>
          </p:cNvPr>
          <p:cNvCxnSpPr>
            <a:cxnSpLocks/>
          </p:cNvCxnSpPr>
          <p:nvPr/>
        </p:nvCxnSpPr>
        <p:spPr>
          <a:xfrm>
            <a:off x="953783" y="3122870"/>
            <a:ext cx="1488482" cy="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24483590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游ゴシック Light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21</TotalTime>
  <Words>106</Words>
  <Application>Microsoft Macintosh PowerPoint</Application>
  <PresentationFormat>ワイド画面</PresentationFormat>
  <Paragraphs>11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游ゴシック</vt:lpstr>
      <vt:lpstr>游ゴシック Light</vt:lpstr>
      <vt:lpstr>Arial</vt:lpstr>
      <vt:lpstr>Segoe UI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TOMOHITO GOHDA</dc:creator>
  <cp:lastModifiedBy>合田 朋仁</cp:lastModifiedBy>
  <cp:revision>21</cp:revision>
  <dcterms:created xsi:type="dcterms:W3CDTF">2024-12-02T23:08:22Z</dcterms:created>
  <dcterms:modified xsi:type="dcterms:W3CDTF">2025-03-22T10:26:22Z</dcterms:modified>
</cp:coreProperties>
</file>